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21F54-64E4-4590-BB6C-389CBFC26C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B49110-CF8E-4A3C-B05E-0A85311F88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059EC-2881-44D4-AF03-CFF766B71B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0FF9AC-2B1A-4DC2-B61D-F57069E351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96CE0-D169-412E-A64B-4397556763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39FD28-533B-499B-B04D-5E715261F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1C3CD-086E-47A9-A2C8-EAD92850F3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172C3-E588-4F85-9A00-F5D91CEC40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62730-F5C7-49C3-95F6-EDBC5DB67C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D2029-EE03-4928-A2AC-65DA7CE2E2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81317-206C-4CFD-A93C-FC12F50C55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EE3FA-5CA5-4D8E-9E6F-30E5A54D8E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1B9704-3424-4104-9D77-A6DB89A2E95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4"/>
          <p:cNvGrpSpPr/>
          <p:nvPr/>
        </p:nvGrpSpPr>
        <p:grpSpPr>
          <a:xfrm>
            <a:off x="900360" y="836640"/>
            <a:ext cx="7010280" cy="2913480"/>
            <a:chOff x="900360" y="836640"/>
            <a:chExt cx="7010280" cy="2913480"/>
          </a:xfrm>
        </p:grpSpPr>
        <p:grpSp>
          <p:nvGrpSpPr>
            <p:cNvPr id="42" name="Group 4"/>
            <p:cNvGrpSpPr/>
            <p:nvPr/>
          </p:nvGrpSpPr>
          <p:grpSpPr>
            <a:xfrm>
              <a:off x="900360" y="836640"/>
              <a:ext cx="7010280" cy="2913480"/>
              <a:chOff x="900360" y="836640"/>
              <a:chExt cx="7010280" cy="2913480"/>
            </a:xfrm>
          </p:grpSpPr>
          <p:pic>
            <p:nvPicPr>
              <p:cNvPr id="43" name="Picture 2" descr=""/>
              <p:cNvPicPr/>
              <p:nvPr/>
            </p:nvPicPr>
            <p:blipFill>
              <a:blip r:embed="rId1"/>
              <a:srcRect l="0" t="0" r="1990" b="0"/>
              <a:stretch/>
            </p:blipFill>
            <p:spPr>
              <a:xfrm>
                <a:off x="900360" y="836640"/>
                <a:ext cx="3527640" cy="2891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3" descr=""/>
              <p:cNvPicPr/>
              <p:nvPr/>
            </p:nvPicPr>
            <p:blipFill>
              <a:blip r:embed="rId2"/>
              <a:srcRect l="0" t="0" r="1988" b="0"/>
              <a:stretch/>
            </p:blipFill>
            <p:spPr>
              <a:xfrm>
                <a:off x="4419360" y="837360"/>
                <a:ext cx="3491280" cy="28796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Straight Connector 180"/>
              <p:cNvSpPr/>
              <p:nvPr/>
            </p:nvSpPr>
            <p:spPr>
              <a:xfrm>
                <a:off x="950400" y="3530880"/>
                <a:ext cx="503640" cy="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Box 9"/>
              <p:cNvSpPr/>
              <p:nvPr/>
            </p:nvSpPr>
            <p:spPr>
              <a:xfrm>
                <a:off x="972000" y="3500640"/>
                <a:ext cx="575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900" spc="-1" strike="noStrike">
                    <a:solidFill>
                      <a:srgbClr val="ffffff"/>
                    </a:solidFill>
                    <a:latin typeface="Calibri"/>
                  </a:rPr>
                  <a:t>50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Straight Connector 180"/>
              <p:cNvSpPr/>
              <p:nvPr/>
            </p:nvSpPr>
            <p:spPr>
              <a:xfrm>
                <a:off x="4572000" y="3517560"/>
                <a:ext cx="503640" cy="0"/>
              </a:xfrm>
              <a:prstGeom prst="line">
                <a:avLst/>
              </a:prstGeom>
              <a:ln w="1260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11"/>
              <p:cNvSpPr/>
              <p:nvPr/>
            </p:nvSpPr>
            <p:spPr>
              <a:xfrm>
                <a:off x="4572000" y="3519000"/>
                <a:ext cx="575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900" spc="-1" strike="noStrike">
                    <a:solidFill>
                      <a:srgbClr val="ffffff"/>
                    </a:solidFill>
                    <a:latin typeface="Calibri"/>
                  </a:rPr>
                  <a:t>50 µ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" name="Rectangle 7"/>
            <p:cNvSpPr/>
            <p:nvPr/>
          </p:nvSpPr>
          <p:spPr>
            <a:xfrm>
              <a:off x="910800" y="83664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8"/>
            <p:cNvSpPr/>
            <p:nvPr/>
          </p:nvSpPr>
          <p:spPr>
            <a:xfrm>
              <a:off x="4425840" y="8366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Rectangle 12"/>
          <p:cNvSpPr/>
          <p:nvPr/>
        </p:nvSpPr>
        <p:spPr>
          <a:xfrm>
            <a:off x="826920" y="4271040"/>
            <a:ext cx="7129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1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tection of polyhydroxyalkanoate (PHA) in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. shibae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by Nile blue staining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s starved under (A) early stationary phase and (B) after three weeks of starvation under light and dark cycle (LD) condition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7T13:14:07Z</dcterms:created>
  <dc:creator>ICBM</dc:creator>
  <dc:description/>
  <dc:language>en-US</dc:language>
  <cp:lastModifiedBy>ICBM</cp:lastModifiedBy>
  <dcterms:modified xsi:type="dcterms:W3CDTF">2013-11-22T11:10:54Z</dcterms:modified>
  <cp:revision>9</cp:revision>
  <dc:subject/>
  <dc:title>Slide 1</dc:title>
</cp:coreProperties>
</file>